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99" r:id="rId2"/>
    <p:sldId id="339" r:id="rId3"/>
    <p:sldId id="349" r:id="rId4"/>
    <p:sldId id="351" r:id="rId5"/>
    <p:sldId id="341" r:id="rId6"/>
    <p:sldId id="350" r:id="rId7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CD2F"/>
    <a:srgbClr val="CDA809"/>
    <a:srgbClr val="ADCE08"/>
    <a:srgbClr val="D6A300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354" autoAdjust="0"/>
    <p:restoredTop sz="91293" autoAdjust="0"/>
  </p:normalViewPr>
  <p:slideViewPr>
    <p:cSldViewPr>
      <p:cViewPr>
        <p:scale>
          <a:sx n="80" d="100"/>
          <a:sy n="80" d="100"/>
        </p:scale>
        <p:origin x="-3270" y="-414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34" d="100"/>
        <a:sy n="134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0EDFCA7F-E9C4-475E-9AD2-282594C57FF3}" type="datetimeFigureOut">
              <a:rPr lang="en-US" smtClean="0"/>
              <a:t>1/24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7100" y="696913"/>
            <a:ext cx="2616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23AB1027-4429-4DB3-8AC2-B80AE393ED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65765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3AB1027-4429-4DB3-8AC2-B80AE393EDB1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928981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3AB1027-4429-4DB3-8AC2-B80AE393EDB1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24093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microsoft.com/office/2007/relationships/hdphoto" Target="../media/hdphoto1.wdp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2" name="Picture 4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535" t="15801" r="18418" b="30441"/>
          <a:stretch/>
        </p:blipFill>
        <p:spPr bwMode="auto">
          <a:xfrm>
            <a:off x="402781" y="1429405"/>
            <a:ext cx="1232545" cy="14356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0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169" t="29631" r="30675" b="2360"/>
          <a:stretch/>
        </p:blipFill>
        <p:spPr bwMode="auto">
          <a:xfrm>
            <a:off x="5242015" y="1793949"/>
            <a:ext cx="1335685" cy="13898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71250" y="969037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8" name="TextBox 97"/>
          <p:cNvSpPr txBox="1"/>
          <p:nvPr/>
        </p:nvSpPr>
        <p:spPr>
          <a:xfrm>
            <a:off x="5601383" y="1106690"/>
            <a:ext cx="8819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arbachol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5699179" y="2969830"/>
            <a:ext cx="7601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=0.003</a:t>
            </a:r>
          </a:p>
        </p:txBody>
      </p:sp>
      <p:pic>
        <p:nvPicPr>
          <p:cNvPr id="103" name="Picture 3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889" t="15557" r="28391" b="27987"/>
          <a:stretch/>
        </p:blipFill>
        <p:spPr bwMode="auto">
          <a:xfrm>
            <a:off x="3621721" y="1427897"/>
            <a:ext cx="1263039" cy="143711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4" name="TextBox 103"/>
          <p:cNvSpPr txBox="1"/>
          <p:nvPr/>
        </p:nvSpPr>
        <p:spPr>
          <a:xfrm>
            <a:off x="3991254" y="1120339"/>
            <a:ext cx="7553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tropine</a:t>
            </a:r>
          </a:p>
        </p:txBody>
      </p:sp>
      <p:sp>
        <p:nvSpPr>
          <p:cNvPr id="105" name="TextBox 104"/>
          <p:cNvSpPr txBox="1"/>
          <p:nvPr/>
        </p:nvSpPr>
        <p:spPr>
          <a:xfrm>
            <a:off x="3983618" y="1363640"/>
            <a:ext cx="7601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=0.018</a:t>
            </a:r>
          </a:p>
        </p:txBody>
      </p:sp>
      <p:pic>
        <p:nvPicPr>
          <p:cNvPr id="106" name="Picture 4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204" t="15476" r="27862" b="27416"/>
          <a:stretch/>
        </p:blipFill>
        <p:spPr bwMode="auto">
          <a:xfrm>
            <a:off x="2015861" y="1429405"/>
            <a:ext cx="1180991" cy="14356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7" name="TextBox 106"/>
          <p:cNvSpPr txBox="1"/>
          <p:nvPr/>
        </p:nvSpPr>
        <p:spPr>
          <a:xfrm>
            <a:off x="2133600" y="1106691"/>
            <a:ext cx="10791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soproterenol</a:t>
            </a:r>
          </a:p>
        </p:txBody>
      </p:sp>
      <p:sp>
        <p:nvSpPr>
          <p:cNvPr id="108" name="TextBox 107"/>
          <p:cNvSpPr txBox="1"/>
          <p:nvPr/>
        </p:nvSpPr>
        <p:spPr>
          <a:xfrm>
            <a:off x="2287404" y="1349992"/>
            <a:ext cx="7601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=0.796</a:t>
            </a:r>
          </a:p>
        </p:txBody>
      </p:sp>
      <p:sp>
        <p:nvSpPr>
          <p:cNvPr id="109" name="TextBox 108"/>
          <p:cNvSpPr txBox="1"/>
          <p:nvPr/>
        </p:nvSpPr>
        <p:spPr>
          <a:xfrm rot="18883599">
            <a:off x="2213515" y="2836200"/>
            <a:ext cx="4251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10" name="TextBox 109"/>
          <p:cNvSpPr txBox="1"/>
          <p:nvPr/>
        </p:nvSpPr>
        <p:spPr>
          <a:xfrm rot="18883599">
            <a:off x="2324158" y="2969620"/>
            <a:ext cx="8417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GBT411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sp>
        <p:nvSpPr>
          <p:cNvPr id="111" name="TextBox 110"/>
          <p:cNvSpPr txBox="1"/>
          <p:nvPr/>
        </p:nvSpPr>
        <p:spPr>
          <a:xfrm rot="18883599">
            <a:off x="3839171" y="2859595"/>
            <a:ext cx="4251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12" name="TextBox 111"/>
          <p:cNvSpPr txBox="1"/>
          <p:nvPr/>
        </p:nvSpPr>
        <p:spPr>
          <a:xfrm rot="18883599">
            <a:off x="4011425" y="2979367"/>
            <a:ext cx="8417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GBT411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sp>
        <p:nvSpPr>
          <p:cNvPr id="113" name="TextBox 112"/>
          <p:cNvSpPr txBox="1"/>
          <p:nvPr/>
        </p:nvSpPr>
        <p:spPr>
          <a:xfrm rot="18883599">
            <a:off x="5632358" y="1567195"/>
            <a:ext cx="4251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14" name="TextBox 113"/>
          <p:cNvSpPr txBox="1"/>
          <p:nvPr/>
        </p:nvSpPr>
        <p:spPr>
          <a:xfrm rot="18883599">
            <a:off x="6042582" y="1412205"/>
            <a:ext cx="8417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GBT411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sp>
        <p:nvSpPr>
          <p:cNvPr id="119" name="TextBox 118"/>
          <p:cNvSpPr txBox="1"/>
          <p:nvPr/>
        </p:nvSpPr>
        <p:spPr>
          <a:xfrm rot="16200000">
            <a:off x="1271113" y="1973638"/>
            <a:ext cx="11737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% HR change </a:t>
            </a:r>
          </a:p>
        </p:txBody>
      </p:sp>
      <p:sp>
        <p:nvSpPr>
          <p:cNvPr id="120" name="TextBox 119"/>
          <p:cNvSpPr txBox="1"/>
          <p:nvPr/>
        </p:nvSpPr>
        <p:spPr>
          <a:xfrm rot="16200000">
            <a:off x="2891415" y="1953159"/>
            <a:ext cx="11737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% HR change </a:t>
            </a:r>
          </a:p>
        </p:txBody>
      </p:sp>
      <p:sp>
        <p:nvSpPr>
          <p:cNvPr id="121" name="TextBox 120"/>
          <p:cNvSpPr txBox="1"/>
          <p:nvPr/>
        </p:nvSpPr>
        <p:spPr>
          <a:xfrm rot="16200000">
            <a:off x="4513414" y="2196047"/>
            <a:ext cx="11737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% HR change </a:t>
            </a:r>
          </a:p>
        </p:txBody>
      </p:sp>
      <p:sp>
        <p:nvSpPr>
          <p:cNvPr id="124" name="TextBox 123"/>
          <p:cNvSpPr txBox="1"/>
          <p:nvPr/>
        </p:nvSpPr>
        <p:spPr>
          <a:xfrm>
            <a:off x="765127" y="1129857"/>
            <a:ext cx="7713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aseline</a:t>
            </a:r>
          </a:p>
        </p:txBody>
      </p:sp>
      <p:sp>
        <p:nvSpPr>
          <p:cNvPr id="125" name="TextBox 124"/>
          <p:cNvSpPr txBox="1"/>
          <p:nvPr/>
        </p:nvSpPr>
        <p:spPr>
          <a:xfrm>
            <a:off x="754740" y="1349992"/>
            <a:ext cx="7601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=0.026</a:t>
            </a:r>
          </a:p>
        </p:txBody>
      </p:sp>
      <p:sp>
        <p:nvSpPr>
          <p:cNvPr id="126" name="TextBox 125"/>
          <p:cNvSpPr txBox="1"/>
          <p:nvPr/>
        </p:nvSpPr>
        <p:spPr>
          <a:xfrm rot="18883599">
            <a:off x="650925" y="2867214"/>
            <a:ext cx="4251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27" name="TextBox 126"/>
          <p:cNvSpPr txBox="1"/>
          <p:nvPr/>
        </p:nvSpPr>
        <p:spPr>
          <a:xfrm rot="18883599">
            <a:off x="761568" y="3000634"/>
            <a:ext cx="8417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GBT411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</a:p>
        </p:txBody>
      </p:sp>
      <p:sp>
        <p:nvSpPr>
          <p:cNvPr id="128" name="TextBox 127"/>
          <p:cNvSpPr txBox="1"/>
          <p:nvPr/>
        </p:nvSpPr>
        <p:spPr>
          <a:xfrm rot="16200000">
            <a:off x="-155696" y="1986290"/>
            <a:ext cx="8931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R (bpm) </a:t>
            </a:r>
          </a:p>
        </p:txBody>
      </p:sp>
      <p:sp>
        <p:nvSpPr>
          <p:cNvPr id="123" name="TextBox 122"/>
          <p:cNvSpPr txBox="1"/>
          <p:nvPr/>
        </p:nvSpPr>
        <p:spPr>
          <a:xfrm>
            <a:off x="1652039" y="969037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29" name="TextBox 128"/>
          <p:cNvSpPr txBox="1"/>
          <p:nvPr/>
        </p:nvSpPr>
        <p:spPr>
          <a:xfrm>
            <a:off x="3259703" y="969037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30" name="TextBox 129"/>
          <p:cNvSpPr txBox="1"/>
          <p:nvPr/>
        </p:nvSpPr>
        <p:spPr>
          <a:xfrm>
            <a:off x="4909873" y="969037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31" name="Rectangle 130"/>
          <p:cNvSpPr/>
          <p:nvPr/>
        </p:nvSpPr>
        <p:spPr>
          <a:xfrm>
            <a:off x="0" y="3468469"/>
            <a:ext cx="6883751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. The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GBT411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mutant  displayed aberrant response to autonomic stimuli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hown are changes of HR in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GBT411-/-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omozygous fish at 16 months in response to different autonomic stimuli. N=9-20 animal per group. Unpaired student’s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t-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est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9559864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11000" contrast="3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99639" y="696326"/>
            <a:ext cx="4070083" cy="509487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10" name="Straight Connector 9"/>
          <p:cNvCxnSpPr/>
          <p:nvPr/>
        </p:nvCxnSpPr>
        <p:spPr>
          <a:xfrm>
            <a:off x="4770683" y="5651810"/>
            <a:ext cx="435934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1566642" y="2494166"/>
            <a:ext cx="6502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V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4102070" y="3243763"/>
            <a:ext cx="6502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V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2545655" y="1120899"/>
            <a:ext cx="6502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A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4526236" y="2022821"/>
            <a:ext cx="6502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A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1270465" y="685800"/>
            <a:ext cx="6687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najb6</a:t>
            </a:r>
          </a:p>
        </p:txBody>
      </p:sp>
      <p:sp>
        <p:nvSpPr>
          <p:cNvPr id="2" name="Rectangle 1"/>
          <p:cNvSpPr/>
          <p:nvPr/>
        </p:nvSpPr>
        <p:spPr>
          <a:xfrm>
            <a:off x="1" y="6059999"/>
            <a:ext cx="6857999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hown are immunostaining of a whole mice heart section using an anti-Dnajb6 antibody. </a:t>
            </a:r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Scale bar: 50 μm. RA, rigt atrium. RV, right ventricle. LA, left atrium. LV, left ventricle.</a:t>
            </a:r>
            <a:endParaRPr lang="en-US" sz="1200" dirty="0"/>
          </a:p>
        </p:txBody>
      </p:sp>
      <p:sp>
        <p:nvSpPr>
          <p:cNvPr id="25" name="Rectangle 24"/>
          <p:cNvSpPr/>
          <p:nvPr/>
        </p:nvSpPr>
        <p:spPr>
          <a:xfrm>
            <a:off x="-1" y="5867400"/>
            <a:ext cx="68580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. Dnajb6 is ubiquitously expressed in 4 cardiac chambers in mouse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25078627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24"/>
          <p:cNvSpPr txBox="1">
            <a:spLocks noChangeArrowheads="1"/>
          </p:cNvSpPr>
          <p:nvPr/>
        </p:nvSpPr>
        <p:spPr bwMode="auto">
          <a:xfrm>
            <a:off x="762000" y="1869626"/>
            <a:ext cx="406400" cy="4603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en-US" sz="2400" b="1" dirty="0">
                <a:solidFill>
                  <a:schemeClr val="tx1"/>
                </a:solidFill>
              </a:rPr>
              <a:t>C</a:t>
            </a:r>
          </a:p>
        </p:txBody>
      </p:sp>
      <p:sp>
        <p:nvSpPr>
          <p:cNvPr id="46" name="Rectangle 45"/>
          <p:cNvSpPr/>
          <p:nvPr/>
        </p:nvSpPr>
        <p:spPr>
          <a:xfrm>
            <a:off x="23750" y="64506"/>
            <a:ext cx="6816224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3</a:t>
            </a:r>
            <a:endParaRPr lang="en-US" sz="1600" dirty="0"/>
          </a:p>
        </p:txBody>
      </p:sp>
      <p:grpSp>
        <p:nvGrpSpPr>
          <p:cNvPr id="37" name="Group 36"/>
          <p:cNvGrpSpPr/>
          <p:nvPr/>
        </p:nvGrpSpPr>
        <p:grpSpPr>
          <a:xfrm>
            <a:off x="1219200" y="602302"/>
            <a:ext cx="2356031" cy="1378898"/>
            <a:chOff x="2019374" y="1490643"/>
            <a:chExt cx="3738611" cy="2341003"/>
          </a:xfrm>
        </p:grpSpPr>
        <p:pic>
          <p:nvPicPr>
            <p:cNvPr id="48" name="Picture 2" descr="Z:\SHARED\Ding Yonghe\Ding-dnajb6_SSS\RNAseq-Genewiz(3-05-21)\GroupC-vs-GroupD-DEG\PCA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1636" r="18500" b="26363"/>
            <a:stretch/>
          </p:blipFill>
          <p:spPr bwMode="auto">
            <a:xfrm>
              <a:off x="2019374" y="1905000"/>
              <a:ext cx="3738611" cy="192664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9" name="TextBox 48"/>
            <p:cNvSpPr txBox="1"/>
            <p:nvPr/>
          </p:nvSpPr>
          <p:spPr>
            <a:xfrm>
              <a:off x="3116707" y="1490643"/>
              <a:ext cx="900027" cy="4702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solidFill>
                    <a:schemeClr val="tx1"/>
                  </a:solidFill>
                </a:rPr>
                <a:t>WT </a:t>
              </a:r>
              <a:endParaRPr lang="en-US" sz="1200" i="1" baseline="30000" dirty="0">
                <a:solidFill>
                  <a:schemeClr val="tx1"/>
                </a:solidFill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3955192" y="1519558"/>
              <a:ext cx="1361057" cy="4702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solidFill>
                    <a:schemeClr val="tx1"/>
                  </a:solidFill>
                </a:rPr>
                <a:t> </a:t>
              </a:r>
              <a:r>
                <a:rPr lang="en-US" sz="1200" i="1" dirty="0">
                  <a:solidFill>
                    <a:schemeClr val="tx1"/>
                  </a:solidFill>
                </a:rPr>
                <a:t>Dnajb6</a:t>
              </a:r>
              <a:r>
                <a:rPr lang="en-US" sz="1200" i="1" baseline="30000" dirty="0">
                  <a:solidFill>
                    <a:schemeClr val="tx1"/>
                  </a:solidFill>
                </a:rPr>
                <a:t>+/-</a:t>
              </a:r>
            </a:p>
          </p:txBody>
        </p:sp>
        <p:pic>
          <p:nvPicPr>
            <p:cNvPr id="51" name="Picture 2" descr="Z:\SHARED\Ding Yonghe\Ding-dnajb6_SSS\RNAseq-Genewiz(3-05-21)\GroupC-vs-GroupD-DEG\PCA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3966" t="46243" r="11315" b="49224"/>
            <a:stretch/>
          </p:blipFill>
          <p:spPr bwMode="auto">
            <a:xfrm>
              <a:off x="3853021" y="1647740"/>
              <a:ext cx="220244" cy="20399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2" name="Picture 2" descr="Z:\SHARED\Ding Yonghe\Ding-dnajb6_SSS\RNAseq-Genewiz(3-05-21)\GroupC-vs-GroupD-DEG\PCA.pn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3966" t="50776" r="11315" b="44690"/>
            <a:stretch/>
          </p:blipFill>
          <p:spPr bwMode="auto">
            <a:xfrm>
              <a:off x="2982373" y="1647740"/>
              <a:ext cx="229638" cy="2126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53" name="TextBox 24"/>
          <p:cNvSpPr txBox="1">
            <a:spLocks noChangeArrowheads="1"/>
          </p:cNvSpPr>
          <p:nvPr/>
        </p:nvSpPr>
        <p:spPr bwMode="auto">
          <a:xfrm>
            <a:off x="762000" y="457200"/>
            <a:ext cx="370614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en-US" sz="2400" b="1" dirty="0">
                <a:solidFill>
                  <a:schemeClr val="tx1"/>
                </a:solidFill>
              </a:rPr>
              <a:t>A</a:t>
            </a:r>
          </a:p>
        </p:txBody>
      </p:sp>
      <p:pic>
        <p:nvPicPr>
          <p:cNvPr id="55" name="Picture 7" descr="Chart&#10;&#10;Description automatically generated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984" r="15862" b="10798"/>
          <a:stretch/>
        </p:blipFill>
        <p:spPr bwMode="auto">
          <a:xfrm>
            <a:off x="3796597" y="933517"/>
            <a:ext cx="2356436" cy="32254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6" name="TextBox 55"/>
          <p:cNvSpPr txBox="1"/>
          <p:nvPr/>
        </p:nvSpPr>
        <p:spPr>
          <a:xfrm>
            <a:off x="4884835" y="649802"/>
            <a:ext cx="628139" cy="3337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chemeClr val="tx1"/>
                </a:solidFill>
              </a:rPr>
              <a:t>WT </a:t>
            </a:r>
            <a:endParaRPr lang="en-US" sz="1200" i="1" baseline="30000" dirty="0">
              <a:solidFill>
                <a:schemeClr val="tx1"/>
              </a:solidFill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3929235" y="647578"/>
            <a:ext cx="1176044" cy="3337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chemeClr val="tx1"/>
                </a:solidFill>
              </a:rPr>
              <a:t> </a:t>
            </a:r>
            <a:r>
              <a:rPr lang="en-US" sz="1200" i="1" dirty="0">
                <a:solidFill>
                  <a:schemeClr val="tx1"/>
                </a:solidFill>
              </a:rPr>
              <a:t>Dnajb6</a:t>
            </a:r>
            <a:r>
              <a:rPr lang="en-US" sz="1200" i="1" baseline="30000" dirty="0">
                <a:solidFill>
                  <a:schemeClr val="tx1"/>
                </a:solidFill>
              </a:rPr>
              <a:t>+/-</a:t>
            </a:r>
          </a:p>
        </p:txBody>
      </p:sp>
      <p:sp>
        <p:nvSpPr>
          <p:cNvPr id="58" name="TextBox 57"/>
          <p:cNvSpPr txBox="1"/>
          <p:nvPr/>
        </p:nvSpPr>
        <p:spPr>
          <a:xfrm rot="16200000">
            <a:off x="5067849" y="4052053"/>
            <a:ext cx="7356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chemeClr val="tx1"/>
                </a:solidFill>
              </a:rPr>
              <a:t>WT-3 </a:t>
            </a:r>
            <a:endParaRPr lang="en-US" sz="1200" i="1" baseline="30000" dirty="0">
              <a:solidFill>
                <a:schemeClr val="tx1"/>
              </a:solidFill>
            </a:endParaRPr>
          </a:p>
        </p:txBody>
      </p:sp>
      <p:sp>
        <p:nvSpPr>
          <p:cNvPr id="59" name="TextBox 58"/>
          <p:cNvSpPr txBox="1"/>
          <p:nvPr/>
        </p:nvSpPr>
        <p:spPr>
          <a:xfrm rot="16200000">
            <a:off x="3742734" y="4223159"/>
            <a:ext cx="10778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solidFill>
                  <a:schemeClr val="tx1"/>
                </a:solidFill>
              </a:rPr>
              <a:t>Dnajb6</a:t>
            </a:r>
            <a:r>
              <a:rPr lang="en-US" sz="1200" i="1" baseline="30000" dirty="0">
                <a:solidFill>
                  <a:schemeClr val="tx1"/>
                </a:solidFill>
              </a:rPr>
              <a:t>+/-</a:t>
            </a:r>
            <a:r>
              <a:rPr lang="en-US" sz="1200" i="1" dirty="0">
                <a:solidFill>
                  <a:schemeClr val="tx1"/>
                </a:solidFill>
              </a:rPr>
              <a:t>-1</a:t>
            </a:r>
            <a:endParaRPr lang="en-US" sz="1200" i="1" baseline="30000" dirty="0">
              <a:solidFill>
                <a:schemeClr val="tx1"/>
              </a:solidFill>
            </a:endParaRPr>
          </a:p>
        </p:txBody>
      </p:sp>
      <p:sp>
        <p:nvSpPr>
          <p:cNvPr id="60" name="TextBox 59"/>
          <p:cNvSpPr txBox="1"/>
          <p:nvPr/>
        </p:nvSpPr>
        <p:spPr>
          <a:xfrm rot="16200000">
            <a:off x="3968981" y="4223161"/>
            <a:ext cx="10778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solidFill>
                  <a:schemeClr val="tx1"/>
                </a:solidFill>
              </a:rPr>
              <a:t>Dnajb6</a:t>
            </a:r>
            <a:r>
              <a:rPr lang="en-US" sz="1200" i="1" baseline="30000" dirty="0">
                <a:solidFill>
                  <a:schemeClr val="tx1"/>
                </a:solidFill>
              </a:rPr>
              <a:t>+/-</a:t>
            </a:r>
            <a:r>
              <a:rPr lang="en-US" sz="1200" i="1" dirty="0">
                <a:solidFill>
                  <a:schemeClr val="tx1"/>
                </a:solidFill>
              </a:rPr>
              <a:t>-2</a:t>
            </a:r>
            <a:endParaRPr lang="en-US" sz="1200" i="1" baseline="30000" dirty="0">
              <a:solidFill>
                <a:schemeClr val="tx1"/>
              </a:solidFill>
            </a:endParaRPr>
          </a:p>
        </p:txBody>
      </p:sp>
      <p:sp>
        <p:nvSpPr>
          <p:cNvPr id="61" name="TextBox 60"/>
          <p:cNvSpPr txBox="1"/>
          <p:nvPr/>
        </p:nvSpPr>
        <p:spPr>
          <a:xfrm rot="16200000">
            <a:off x="4178921" y="4223159"/>
            <a:ext cx="10778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solidFill>
                  <a:schemeClr val="tx1"/>
                </a:solidFill>
              </a:rPr>
              <a:t>Dnajb6</a:t>
            </a:r>
            <a:r>
              <a:rPr lang="en-US" sz="1200" i="1" baseline="30000" dirty="0">
                <a:solidFill>
                  <a:schemeClr val="tx1"/>
                </a:solidFill>
              </a:rPr>
              <a:t>+/-</a:t>
            </a:r>
            <a:r>
              <a:rPr lang="en-US" sz="1200" i="1" dirty="0">
                <a:solidFill>
                  <a:schemeClr val="tx1"/>
                </a:solidFill>
              </a:rPr>
              <a:t>-3</a:t>
            </a:r>
            <a:endParaRPr lang="en-US" sz="1200" i="1" baseline="30000" dirty="0">
              <a:solidFill>
                <a:schemeClr val="tx1"/>
              </a:solidFill>
            </a:endParaRPr>
          </a:p>
        </p:txBody>
      </p:sp>
      <p:sp>
        <p:nvSpPr>
          <p:cNvPr id="62" name="TextBox 61"/>
          <p:cNvSpPr txBox="1"/>
          <p:nvPr/>
        </p:nvSpPr>
        <p:spPr>
          <a:xfrm rot="16200000">
            <a:off x="4845583" y="4052052"/>
            <a:ext cx="7356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chemeClr val="tx1"/>
                </a:solidFill>
              </a:rPr>
              <a:t>WT-2 </a:t>
            </a:r>
            <a:endParaRPr lang="en-US" sz="1200" i="1" baseline="30000" dirty="0">
              <a:solidFill>
                <a:schemeClr val="tx1"/>
              </a:solidFill>
            </a:endParaRPr>
          </a:p>
        </p:txBody>
      </p:sp>
      <p:sp>
        <p:nvSpPr>
          <p:cNvPr id="63" name="TextBox 62"/>
          <p:cNvSpPr txBox="1"/>
          <p:nvPr/>
        </p:nvSpPr>
        <p:spPr>
          <a:xfrm rot="16200000">
            <a:off x="4616233" y="4052053"/>
            <a:ext cx="7356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chemeClr val="tx1"/>
                </a:solidFill>
              </a:rPr>
              <a:t>WT-1 </a:t>
            </a:r>
            <a:endParaRPr lang="en-US" sz="1200" i="1" baseline="30000" dirty="0">
              <a:solidFill>
                <a:schemeClr val="tx1"/>
              </a:solidFill>
            </a:endParaRPr>
          </a:p>
        </p:txBody>
      </p:sp>
      <p:sp>
        <p:nvSpPr>
          <p:cNvPr id="64" name="TextBox 24"/>
          <p:cNvSpPr txBox="1">
            <a:spLocks noChangeArrowheads="1"/>
          </p:cNvSpPr>
          <p:nvPr/>
        </p:nvSpPr>
        <p:spPr bwMode="auto">
          <a:xfrm>
            <a:off x="3604610" y="379310"/>
            <a:ext cx="35779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en-US" sz="2400" b="1" dirty="0">
                <a:solidFill>
                  <a:schemeClr val="tx1"/>
                </a:solidFill>
              </a:rPr>
              <a:t>B</a:t>
            </a:r>
          </a:p>
        </p:txBody>
      </p:sp>
      <p:pic>
        <p:nvPicPr>
          <p:cNvPr id="38" name="Picture 3" descr="Chart, scatter chart&#10;&#10;Description automatically generated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206"/>
          <a:stretch/>
        </p:blipFill>
        <p:spPr bwMode="auto">
          <a:xfrm>
            <a:off x="1014250" y="2114404"/>
            <a:ext cx="2648489" cy="236692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aphicFrame>
        <p:nvGraphicFramePr>
          <p:cNvPr id="30" name="Table 29">
            <a:extLst>
              <a:ext uri="{FF2B5EF4-FFF2-40B4-BE49-F238E27FC236}">
                <a16:creationId xmlns:a16="http://schemas.microsoft.com/office/drawing/2014/main" xmlns="" id="{2E10011E-3C66-438F-8CB1-15CEA2DD93F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57118793"/>
              </p:ext>
            </p:extLst>
          </p:nvPr>
        </p:nvGraphicFramePr>
        <p:xfrm>
          <a:off x="147382" y="4985079"/>
          <a:ext cx="6634418" cy="355417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900618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838200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1318565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557408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410027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</a:tblGrid>
              <a:tr h="2615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genuity Canonical Pathways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-log(p-value)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tio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lecules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26157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I3K/AKT Signaling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2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17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ND1,CSF2RB,IL18R1,ITGA9</a:t>
                      </a:r>
                      <a:endParaRPr lang="en-US" sz="11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26157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ole of Macrophages, Fibroblasts and Endothelial Cells in Rheumatoid Arthritis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7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59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ND1,IL18R1,SOST,WNT2,WNT9B</a:t>
                      </a:r>
                      <a:endParaRPr lang="en-US" sz="11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134753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uroprotective Role of THOP1 in Alzheimer's Disease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5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59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zmb,GZMK,NTS</a:t>
                      </a:r>
                      <a:endParaRPr lang="en-US" sz="11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134753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ole of Osteoblasts, Osteoclasts and Chondrocytes in Rheumatoid Arthritis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5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83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18R1,SOST,WNT2,WNT9B</a:t>
                      </a:r>
                      <a:endParaRPr lang="en-US" sz="11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134753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T3 Pathway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7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22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SF2RB,IL18R1,TGFA</a:t>
                      </a:r>
                      <a:endParaRPr lang="en-US" sz="11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134753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varian Cancer Signaling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4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16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ND1,WNT2,WNT9B</a:t>
                      </a:r>
                      <a:endParaRPr lang="en-US" sz="11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26157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orectal Cancer Metastasis Signaling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3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58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ND1,PTGER1,WNT2,WNT9B</a:t>
                      </a:r>
                      <a:endParaRPr lang="en-US" sz="11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26157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lecular Mechanisms of Cancer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6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25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ND1,DHH,ITGA9,WNT2,WNT9B</a:t>
                      </a:r>
                      <a:endParaRPr lang="en-US" sz="11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134753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ctors Promoting Cardiogenesis in Vertebrates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5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ND1,WNT2,WNT9B</a:t>
                      </a:r>
                      <a:endParaRPr lang="en-US" sz="11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134753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P pathway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2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33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NT2,WNT9B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10"/>
                  </a:ext>
                </a:extLst>
              </a:tr>
              <a:tr h="134753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bB2-ErbB3 Signaling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6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08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ND1,ETV4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11"/>
                  </a:ext>
                </a:extLst>
              </a:tr>
              <a:tr h="134753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ioblastoma Multiforme Signaling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5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82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ND1,WNT2,WNT9B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12"/>
                  </a:ext>
                </a:extLst>
              </a:tr>
              <a:tr h="134753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M-CSF Signaling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86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ND1,CSF2RB</a:t>
                      </a:r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927" marR="7927" marT="792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13"/>
                  </a:ext>
                </a:extLst>
              </a:tr>
            </a:tbl>
          </a:graphicData>
        </a:graphic>
      </p:graphicFrame>
      <p:sp>
        <p:nvSpPr>
          <p:cNvPr id="31" name="TextBox 24">
            <a:extLst>
              <a:ext uri="{FF2B5EF4-FFF2-40B4-BE49-F238E27FC236}">
                <a16:creationId xmlns:a16="http://schemas.microsoft.com/office/drawing/2014/main" xmlns="" id="{C6CBC357-9D35-402F-BC05-2922C859433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8570" y="4578122"/>
            <a:ext cx="37863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en-US" sz="2400" b="1" dirty="0">
                <a:solidFill>
                  <a:schemeClr val="tx1"/>
                </a:solidFill>
              </a:rPr>
              <a:t>D</a:t>
            </a:r>
          </a:p>
        </p:txBody>
      </p:sp>
      <p:sp>
        <p:nvSpPr>
          <p:cNvPr id="2" name="Oval 1"/>
          <p:cNvSpPr/>
          <p:nvPr/>
        </p:nvSpPr>
        <p:spPr>
          <a:xfrm rot="20191430">
            <a:off x="1507637" y="781081"/>
            <a:ext cx="215130" cy="473644"/>
          </a:xfrm>
          <a:prstGeom prst="ellipse">
            <a:avLst/>
          </a:prstGeom>
          <a:noFill/>
          <a:ln w="127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Oval 26"/>
          <p:cNvSpPr/>
          <p:nvPr/>
        </p:nvSpPr>
        <p:spPr>
          <a:xfrm rot="20701721">
            <a:off x="1499788" y="1041169"/>
            <a:ext cx="2043129" cy="647931"/>
          </a:xfrm>
          <a:prstGeom prst="ellipse">
            <a:avLst/>
          </a:prstGeom>
          <a:noFill/>
          <a:ln w="12700"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454145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0" y="6498610"/>
            <a:ext cx="6858000" cy="24929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RNA sequencing identifies transcriptome changes in the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Dnajb6</a:t>
            </a:r>
            <a:r>
              <a:rPr lang="en-US" sz="1200" b="1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+/-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mice atrium.  (A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rincipal component analysis (PCA) reveals the variance in transcriptome distribution in the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Dnajb6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+/-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mice and WT controls at 6 months. Each point represents the projections of individual hearts onto principal component (PC)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Heatmap of genes differentially expressed in the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Dnajb6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+/-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mice and WT controls. Each column represents an individual replicate and there are 3 replicates per group. Each row represents an individual gene.  The color bar represents relative expression of log-transformed, normalized counts with upregulated genes shown in red and downregulated genes in blue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C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Volcano plot shows magnitude and significance of genes that altered in distribution in the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Dnajb6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+/-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mice and WT controls. Genes that significantly downregulated in the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Dnajb6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+/-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mice are plotted in blue (left) and upregulated are plotted in red (right).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(D)  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genuity Pathway Analysis (IPA) of differentially expressed genes in the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Dnajb6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+/-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mice and WT controls. Signaling pathways are organized in the order of significance as –log10 of P value. </a:t>
            </a:r>
          </a:p>
        </p:txBody>
      </p:sp>
    </p:spTree>
    <p:extLst>
      <p:ext uri="{BB962C8B-B14F-4D97-AF65-F5344CB8AC3E}">
        <p14:creationId xmlns:p14="http://schemas.microsoft.com/office/powerpoint/2010/main" val="324480248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3" name="Table 2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32929987"/>
              </p:ext>
            </p:extLst>
          </p:nvPr>
        </p:nvGraphicFramePr>
        <p:xfrm>
          <a:off x="304800" y="750126"/>
          <a:ext cx="6277867" cy="2056384"/>
        </p:xfrm>
        <a:graphic>
          <a:graphicData uri="http://schemas.openxmlformats.org/drawingml/2006/table">
            <a:tbl>
              <a:tblPr firstRow="1" bandRow="1"/>
              <a:tblGrid>
                <a:gridCol w="936860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936860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746547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990600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1093993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963407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</a:tblGrid>
              <a:tr h="54527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b="1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116205" marR="116205" marT="58420" marB="5842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Genotype</a:t>
                      </a:r>
                      <a:endParaRPr lang="en-US" sz="1200" b="1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116205" marR="116205" marT="58420" marB="5842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Age</a:t>
                      </a:r>
                      <a:endParaRPr lang="en-US" sz="1200" b="1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116205" marR="116205" marT="58420" marB="5842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SimSun"/>
                          <a:cs typeface="Arial" panose="020B0604020202020204" pitchFamily="34" charset="0"/>
                        </a:rPr>
                        <a:t>N</a:t>
                      </a:r>
                      <a:endParaRPr lang="en-US" sz="1200" b="1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116205" marR="116205" marT="58420" marB="5842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SA incidence (%)</a:t>
                      </a:r>
                      <a:endParaRPr lang="en-US" sz="1200" b="1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116205" marR="116205" marT="58420" marB="5842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SA Frequency</a:t>
                      </a:r>
                      <a:r>
                        <a:rPr lang="en-US" sz="1200" b="1" kern="1200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200" b="1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200" b="1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epm</a:t>
                      </a:r>
                      <a:r>
                        <a:rPr lang="en-US" sz="1200" b="1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)</a:t>
                      </a:r>
                      <a:endParaRPr lang="en-US" sz="1200" b="1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116205" marR="116205" marT="58420" marB="5842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Heart rate (bpm)</a:t>
                      </a:r>
                      <a:endParaRPr lang="en-US" sz="1200" b="1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66624">
                <a:tc rowSpan="2"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dirty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Baseline</a:t>
                      </a:r>
                    </a:p>
                  </a:txBody>
                  <a:tcPr marL="116205" marR="116205" marT="58420" marB="5842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WT</a:t>
                      </a:r>
                      <a:endParaRPr lang="en-US" sz="1200" b="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116205" marR="116205" marT="58420" marB="5842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10 m</a:t>
                      </a:r>
                      <a:endParaRPr lang="en-US" sz="1200" b="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116205" marR="116205" marT="58420" marB="5842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SimSun"/>
                          <a:cs typeface="Arial" panose="020B0604020202020204" pitchFamily="34" charset="0"/>
                        </a:rPr>
                        <a:t>8</a:t>
                      </a:r>
                      <a:endParaRPr lang="en-US" sz="1200" b="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116205" marR="116205" marT="58420" marB="5842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SimSun"/>
                          <a:cs typeface="Arial" panose="020B0604020202020204" pitchFamily="34" charset="0"/>
                        </a:rPr>
                        <a:t>0.0</a:t>
                      </a:r>
                      <a:endParaRPr lang="en-US" sz="1200" b="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116205" marR="116205" marT="58420" marB="5842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-</a:t>
                      </a:r>
                      <a:endParaRPr lang="en-US" sz="1200" b="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12065" marR="12065" marT="1206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108.8±25.5</a:t>
                      </a:r>
                      <a:endParaRPr lang="en-US" sz="1200" b="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173989">
                <a:tc vMerge="1"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b="0" i="1" baseline="300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116205" marR="116205" marT="58420" marB="5842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1" dirty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GBT411</a:t>
                      </a:r>
                      <a:r>
                        <a:rPr lang="en-US" sz="1200" b="0" i="1" baseline="30000" dirty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-/-</a:t>
                      </a:r>
                    </a:p>
                  </a:txBody>
                  <a:tcPr marL="116205" marR="116205" marT="58420" marB="5842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dirty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10 m</a:t>
                      </a:r>
                    </a:p>
                  </a:txBody>
                  <a:tcPr marL="116205" marR="116205" marT="58420" marB="5842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dirty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8</a:t>
                      </a:r>
                    </a:p>
                  </a:txBody>
                  <a:tcPr marL="116205" marR="116205" marT="58420" marB="5842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dirty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12.5</a:t>
                      </a:r>
                    </a:p>
                  </a:txBody>
                  <a:tcPr marL="116205" marR="116205" marT="58420" marB="5842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1.0</a:t>
                      </a:r>
                      <a:endParaRPr lang="en-US" sz="1200" b="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12065" marR="12065" marT="1206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102.6±9.3</a:t>
                      </a:r>
                      <a:endParaRPr lang="en-US" sz="1200" b="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186752">
                <a:tc rowSpan="2"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dirty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Verapamil</a:t>
                      </a:r>
                    </a:p>
                  </a:txBody>
                  <a:tcPr marL="116205" marR="116205" marT="58420" marB="5842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WT</a:t>
                      </a:r>
                      <a:endParaRPr lang="en-US" sz="1200" b="0" i="0" baseline="300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116205" marR="116205" marT="58420" marB="5842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10 m</a:t>
                      </a:r>
                      <a:endParaRPr lang="en-US" sz="1200" b="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116205" marR="116205" marT="58420" marB="5842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SimSun"/>
                          <a:cs typeface="Arial" panose="020B0604020202020204" pitchFamily="34" charset="0"/>
                        </a:rPr>
                        <a:t>8</a:t>
                      </a:r>
                      <a:endParaRPr lang="en-US" sz="1200" b="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116205" marR="116205" marT="58420" marB="5842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25.0</a:t>
                      </a:r>
                      <a:endParaRPr lang="en-US" sz="1200" b="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116205" marR="116205" marT="58420" marB="5842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3.4±0.6</a:t>
                      </a:r>
                      <a:endParaRPr lang="en-US" sz="1200" b="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12065" marR="12065" marT="1206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80.3±11.5</a:t>
                      </a:r>
                      <a:endParaRPr lang="en-US" sz="1200" b="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168782">
                <a:tc vMerge="1"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b="0" baseline="300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116205" marR="116205" marT="58420" marB="5842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1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GBT411</a:t>
                      </a:r>
                      <a:r>
                        <a:rPr lang="en-US" sz="1200" b="0" i="1" kern="1200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-/-</a:t>
                      </a:r>
                      <a:endParaRPr lang="en-US" sz="1200" b="0" baseline="3000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116205" marR="116205" marT="58420" marB="5842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dirty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10 m</a:t>
                      </a:r>
                    </a:p>
                  </a:txBody>
                  <a:tcPr marL="116205" marR="116205" marT="58420" marB="5842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dirty="0">
                          <a:effectLst/>
                          <a:latin typeface="Arial" panose="020B0604020202020204" pitchFamily="34" charset="0"/>
                          <a:ea typeface="Calibri"/>
                          <a:cs typeface="Arial" panose="020B0604020202020204" pitchFamily="34" charset="0"/>
                        </a:rPr>
                        <a:t>9</a:t>
                      </a:r>
                    </a:p>
                  </a:txBody>
                  <a:tcPr marL="116205" marR="116205" marT="58420" marB="5842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88.9*</a:t>
                      </a:r>
                      <a:endParaRPr lang="en-US" sz="1200" b="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116205" marR="116205" marT="58420" marB="5842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5.2±3.2</a:t>
                      </a:r>
                      <a:endParaRPr lang="en-US" sz="1200" b="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12065" marR="12065" marT="1206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71.5±8.8*</a:t>
                      </a:r>
                      <a:endParaRPr lang="en-US" sz="1200" b="0" dirty="0"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</a:tbl>
          </a:graphicData>
        </a:graphic>
      </p:graphicFrame>
      <p:sp>
        <p:nvSpPr>
          <p:cNvPr id="24" name="Rectangle 23"/>
          <p:cNvSpPr/>
          <p:nvPr/>
        </p:nvSpPr>
        <p:spPr>
          <a:xfrm>
            <a:off x="304800" y="473127"/>
            <a:ext cx="616602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l Table 1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CG quantification of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GBT411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t 10 months of age</a:t>
            </a:r>
            <a:endParaRPr lang="en-US" sz="12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228600" y="2766322"/>
            <a:ext cx="64008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A, sinus arrest. </a:t>
            </a:r>
            <a:r>
              <a:rPr lang="en-US" sz="12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pm</a:t>
            </a:r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episode per minute. bpm, beats per minute. N=8-9. *, </a:t>
            </a:r>
            <a:r>
              <a:rPr lang="en-US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&lt;0.05, data are expressed as </a:t>
            </a:r>
            <a:r>
              <a:rPr lang="en-US" sz="12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an±SEM</a:t>
            </a:r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For SA incidence comparison, Chi-square test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For heart rate comparison, unpaired student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t-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est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59714015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Rectangle 23"/>
          <p:cNvSpPr/>
          <p:nvPr/>
        </p:nvSpPr>
        <p:spPr>
          <a:xfrm>
            <a:off x="304800" y="381000"/>
            <a:ext cx="6166022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l Table 2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Quantitative RT-PCR primers used to validate differentially expressed (DE) genes identified from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RNAseq</a:t>
            </a:r>
            <a:endParaRPr lang="en-US" sz="12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04520544"/>
              </p:ext>
            </p:extLst>
          </p:nvPr>
        </p:nvGraphicFramePr>
        <p:xfrm>
          <a:off x="1292311" y="1066800"/>
          <a:ext cx="3965489" cy="634046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93689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2971800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</a:tblGrid>
              <a:tr h="305428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rimer</a:t>
                      </a:r>
                      <a:r>
                        <a:rPr lang="en-US" sz="1200" baseline="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name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SimSun"/>
                        <a:cs typeface="Arial" panose="020B0604020202020204" pitchFamily="34" charset="0"/>
                      </a:endParaRPr>
                    </a:p>
                  </a:txBody>
                  <a:tcPr marL="15908" marR="1590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er Sequence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SimSun"/>
                        <a:cs typeface="Arial" panose="020B0604020202020204" pitchFamily="34" charset="0"/>
                      </a:endParaRPr>
                    </a:p>
                  </a:txBody>
                  <a:tcPr marL="15908" marR="1590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5271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pdh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F</a:t>
                      </a:r>
                      <a:endParaRPr lang="en-US" sz="1200" b="0" i="1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5908" marR="1590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AGGTCGGTGTGAACGGATTTG-3’</a:t>
                      </a:r>
                    </a:p>
                  </a:txBody>
                  <a:tcPr marL="15908" marR="1590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15271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pdh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R</a:t>
                      </a:r>
                      <a:endParaRPr lang="en-US" sz="1200" i="1" dirty="0">
                        <a:effectLst/>
                        <a:latin typeface="Arial" panose="020B0604020202020204" pitchFamily="34" charset="0"/>
                        <a:ea typeface="SimSun"/>
                        <a:cs typeface="Arial" panose="020B0604020202020204" pitchFamily="34" charset="0"/>
                      </a:endParaRPr>
                    </a:p>
                  </a:txBody>
                  <a:tcPr marL="15908" marR="1590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 GTAGACCATGTAGTTGAGGTCA-3’</a:t>
                      </a:r>
                    </a:p>
                  </a:txBody>
                  <a:tcPr marL="15908" marR="1590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15271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c24-F</a:t>
                      </a:r>
                      <a:endParaRPr lang="en-US" sz="1200" b="0" i="1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5908" marR="1590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 AGCAACAGAGGAGAAGCCAG-3’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SimSun"/>
                        <a:cs typeface="Arial" panose="020B0604020202020204" pitchFamily="34" charset="0"/>
                      </a:endParaRPr>
                    </a:p>
                  </a:txBody>
                  <a:tcPr marL="15908" marR="1590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15271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c24-R</a:t>
                      </a:r>
                      <a:endParaRPr lang="en-US" sz="1200" i="1" dirty="0">
                        <a:effectLst/>
                        <a:latin typeface="Arial" panose="020B0604020202020204" pitchFamily="34" charset="0"/>
                        <a:ea typeface="SimSun"/>
                        <a:cs typeface="Arial" panose="020B0604020202020204" pitchFamily="34" charset="0"/>
                      </a:endParaRPr>
                    </a:p>
                  </a:txBody>
                  <a:tcPr marL="15908" marR="1590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 TCACAGACGATGGCTAATGC-3’</a:t>
                      </a:r>
                    </a:p>
                  </a:txBody>
                  <a:tcPr marL="15908" marR="1590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15271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xdc1-F</a:t>
                      </a:r>
                      <a:endParaRPr lang="en-US" sz="1200" b="0" i="1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5908" marR="1590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 CTGCAAGAGGGCTTCAATG-3’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SimSun"/>
                        <a:cs typeface="Arial" panose="020B0604020202020204" pitchFamily="34" charset="0"/>
                      </a:endParaRPr>
                    </a:p>
                  </a:txBody>
                  <a:tcPr marL="15908" marR="1590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15271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xdc1-R</a:t>
                      </a:r>
                      <a:endParaRPr lang="en-US" sz="1200" i="1" dirty="0">
                        <a:effectLst/>
                        <a:latin typeface="Arial" panose="020B0604020202020204" pitchFamily="34" charset="0"/>
                        <a:ea typeface="SimSun"/>
                        <a:cs typeface="Arial" panose="020B0604020202020204" pitchFamily="34" charset="0"/>
                      </a:endParaRPr>
                    </a:p>
                  </a:txBody>
                  <a:tcPr marL="15908" marR="1590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 AACTGACCAACAATCTCGATG-3’ </a:t>
                      </a:r>
                    </a:p>
                  </a:txBody>
                  <a:tcPr marL="15908" marR="1590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15271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c9-F</a:t>
                      </a:r>
                      <a:endParaRPr lang="en-US" sz="1200" b="0" i="1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5908" marR="1590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 GTGAACGGTGAGAATGTGG-3’ </a:t>
                      </a:r>
                    </a:p>
                  </a:txBody>
                  <a:tcPr marL="15908" marR="1590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15271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c9-R</a:t>
                      </a:r>
                      <a:endParaRPr lang="en-US" sz="1200" i="1" dirty="0">
                        <a:effectLst/>
                        <a:latin typeface="Arial" panose="020B0604020202020204" pitchFamily="34" charset="0"/>
                        <a:ea typeface="SimSun"/>
                        <a:cs typeface="Arial" panose="020B0604020202020204" pitchFamily="34" charset="0"/>
                      </a:endParaRPr>
                    </a:p>
                  </a:txBody>
                  <a:tcPr marL="15908" marR="1590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 TTTCTTCATGGTGCAGAGC-3’</a:t>
                      </a:r>
                    </a:p>
                  </a:txBody>
                  <a:tcPr marL="15908" marR="1590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10"/>
                  </a:ext>
                </a:extLst>
              </a:tr>
              <a:tr h="15271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jb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F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5908" marR="1590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 GAAGGTTACCTTTACCCGAATC-3’</a:t>
                      </a:r>
                    </a:p>
                  </a:txBody>
                  <a:tcPr marL="15908" marR="1590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17"/>
                  </a:ext>
                </a:extLst>
              </a:tr>
              <a:tr h="15271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jb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R</a:t>
                      </a:r>
                      <a:endParaRPr lang="en-US" sz="1200" i="1" dirty="0">
                        <a:effectLst/>
                        <a:latin typeface="Arial" panose="020B0604020202020204" pitchFamily="34" charset="0"/>
                        <a:ea typeface="SimSun"/>
                        <a:cs typeface="Arial" panose="020B0604020202020204" pitchFamily="34" charset="0"/>
                      </a:endParaRPr>
                    </a:p>
                  </a:txBody>
                  <a:tcPr marL="15908" marR="1590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 GGTTAAGCAGGATGCAGATG-3’</a:t>
                      </a:r>
                    </a:p>
                  </a:txBody>
                  <a:tcPr marL="15908" marR="1590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18"/>
                  </a:ext>
                </a:extLst>
              </a:tr>
              <a:tr h="15271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nt2-F </a:t>
                      </a:r>
                      <a:endParaRPr lang="en-US" sz="1200" i="1" dirty="0">
                        <a:effectLst/>
                        <a:latin typeface="Arial" panose="020B0604020202020204" pitchFamily="34" charset="0"/>
                        <a:ea typeface="SimSun"/>
                        <a:cs typeface="Arial" panose="020B0604020202020204" pitchFamily="34" charset="0"/>
                      </a:endParaRPr>
                    </a:p>
                  </a:txBody>
                  <a:tcPr marL="15908" marR="1590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 CTCGGTGGAATCTGGCTCTG-3’</a:t>
                      </a:r>
                    </a:p>
                  </a:txBody>
                  <a:tcPr marL="15908" marR="1590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11"/>
                  </a:ext>
                </a:extLst>
              </a:tr>
              <a:tr h="15271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nt2-R</a:t>
                      </a:r>
                      <a:endParaRPr lang="en-US" sz="1200" b="0" i="1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5908" marR="1590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 CACATTGTCACACATCACCCT-3’</a:t>
                      </a:r>
                    </a:p>
                  </a:txBody>
                  <a:tcPr marL="15908" marR="1590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12"/>
                  </a:ext>
                </a:extLst>
              </a:tr>
              <a:tr h="15271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nt9b-F</a:t>
                      </a:r>
                      <a:endParaRPr lang="en-US" sz="1200" i="1" dirty="0">
                        <a:effectLst/>
                        <a:latin typeface="Arial" panose="020B0604020202020204" pitchFamily="34" charset="0"/>
                        <a:ea typeface="SimSun"/>
                        <a:cs typeface="Arial" panose="020B0604020202020204" pitchFamily="34" charset="0"/>
                      </a:endParaRPr>
                    </a:p>
                  </a:txBody>
                  <a:tcPr marL="15908" marR="1590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 AAGAGAGGAAGCAAGGACC-3’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5908" marR="1590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13"/>
                  </a:ext>
                </a:extLst>
              </a:tr>
              <a:tr h="15271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nt9b-R</a:t>
                      </a:r>
                      <a:endParaRPr lang="en-US" sz="1200" b="0" i="1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5908" marR="1590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 TCCAACAGGTACGAACAGC-3’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SimSun"/>
                        <a:cs typeface="Arial" panose="020B0604020202020204" pitchFamily="34" charset="0"/>
                      </a:endParaRPr>
                    </a:p>
                  </a:txBody>
                  <a:tcPr marL="15908" marR="1590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14"/>
                  </a:ext>
                </a:extLst>
              </a:tr>
              <a:tr h="15271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nd1-F</a:t>
                      </a:r>
                      <a:endParaRPr lang="en-US" sz="1200" i="1" dirty="0">
                        <a:effectLst/>
                        <a:latin typeface="Arial" panose="020B0604020202020204" pitchFamily="34" charset="0"/>
                        <a:ea typeface="SimSun"/>
                        <a:cs typeface="Arial" panose="020B0604020202020204" pitchFamily="34" charset="0"/>
                      </a:endParaRPr>
                    </a:p>
                  </a:txBody>
                  <a:tcPr marL="15908" marR="1590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 GTGAAGTTCATTTCCAACCCAC-3’	</a:t>
                      </a:r>
                    </a:p>
                  </a:txBody>
                  <a:tcPr marL="15908" marR="1590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15"/>
                  </a:ext>
                </a:extLst>
              </a:tr>
              <a:tr h="15271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nd1-R</a:t>
                      </a:r>
                      <a:endParaRPr lang="en-US" sz="1200" b="0" i="1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5908" marR="1590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 TGACCGGGTCACACTTGATG-3’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SimSun"/>
                        <a:cs typeface="Arial" panose="020B0604020202020204" pitchFamily="34" charset="0"/>
                      </a:endParaRPr>
                    </a:p>
                  </a:txBody>
                  <a:tcPr marL="15908" marR="1590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16"/>
                  </a:ext>
                </a:extLst>
              </a:tr>
              <a:tr h="15271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XYD5-F</a:t>
                      </a:r>
                      <a:endParaRPr lang="en-US" sz="1200" i="1" dirty="0">
                        <a:effectLst/>
                        <a:latin typeface="Arial" panose="020B0604020202020204" pitchFamily="34" charset="0"/>
                        <a:ea typeface="SimSun"/>
                        <a:cs typeface="Arial" panose="020B0604020202020204" pitchFamily="34" charset="0"/>
                      </a:endParaRPr>
                    </a:p>
                  </a:txBody>
                  <a:tcPr marL="15908" marR="1590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 CCAAACCGAGACCCAGCAA-3’</a:t>
                      </a:r>
                    </a:p>
                  </a:txBody>
                  <a:tcPr marL="15908" marR="1590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19"/>
                  </a:ext>
                </a:extLst>
              </a:tr>
              <a:tr h="15271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XYD5-R</a:t>
                      </a:r>
                      <a:endParaRPr lang="en-US" sz="1200" b="0" i="1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5908" marR="1590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 AACTGCCTACACTTCCCACTA-3’</a:t>
                      </a:r>
                    </a:p>
                  </a:txBody>
                  <a:tcPr marL="15908" marR="1590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20"/>
                  </a:ext>
                </a:extLst>
              </a:tr>
              <a:tr h="152714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cnh7-F</a:t>
                      </a:r>
                      <a:endParaRPr lang="en-US" sz="1200" i="1" dirty="0">
                        <a:effectLst/>
                        <a:latin typeface="Arial" panose="020B0604020202020204" pitchFamily="34" charset="0"/>
                        <a:ea typeface="SimSun"/>
                        <a:cs typeface="Arial" panose="020B0604020202020204" pitchFamily="34" charset="0"/>
                      </a:endParaRPr>
                    </a:p>
                  </a:txBody>
                  <a:tcPr marL="15908" marR="1590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 CCAGGAAACTGGACCGATACT-3’</a:t>
                      </a:r>
                    </a:p>
                  </a:txBody>
                  <a:tcPr marL="15908" marR="1590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21"/>
                  </a:ext>
                </a:extLst>
              </a:tr>
              <a:tr h="15271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cnh7-R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5908" marR="1590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 CCAATCGCATACCAGATGCAA-3’</a:t>
                      </a:r>
                    </a:p>
                  </a:txBody>
                  <a:tcPr marL="15908" marR="1590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22"/>
                  </a:ext>
                </a:extLst>
              </a:tr>
              <a:tr h="15271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h20-F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5908" marR="1590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 ATGTGGACTACGGGTAGAATGA-3’</a:t>
                      </a:r>
                    </a:p>
                  </a:txBody>
                  <a:tcPr marL="15908" marR="1590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23"/>
                  </a:ext>
                </a:extLst>
              </a:tr>
              <a:tr h="15271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h20-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5908" marR="1590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 GTGCTGGAGAGAACAGTGGC-3’</a:t>
                      </a:r>
                    </a:p>
                  </a:txBody>
                  <a:tcPr marL="15908" marR="1590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2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038460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905</TotalTime>
  <Words>685</Words>
  <Application>Microsoft Office PowerPoint</Application>
  <PresentationFormat>On-screen Show (4:3)</PresentationFormat>
  <Paragraphs>187</Paragraphs>
  <Slides>6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ngchun</dc:creator>
  <cp:lastModifiedBy>Yonghe   Ding</cp:lastModifiedBy>
  <cp:revision>423</cp:revision>
  <cp:lastPrinted>2020-11-23T19:42:38Z</cp:lastPrinted>
  <dcterms:created xsi:type="dcterms:W3CDTF">2006-08-16T00:00:00Z</dcterms:created>
  <dcterms:modified xsi:type="dcterms:W3CDTF">2022-01-24T23:15:24Z</dcterms:modified>
</cp:coreProperties>
</file>